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56" r:id="rId5"/>
  </p:sldIdLst>
  <p:sldSz cx="6858000" cy="8686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1" d="100"/>
          <a:sy n="121" d="100"/>
        </p:scale>
        <p:origin x="395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eck, Craig J." userId="d588c584-9c58-4480-93d4-d317c75b1e10" providerId="ADAL" clId="{4EF29121-3155-482A-B3B6-A177FB547C8B}"/>
    <pc:docChg chg="undo custSel modSld modMainMaster">
      <pc:chgData name="Heck, Craig J." userId="d588c584-9c58-4480-93d4-d317c75b1e10" providerId="ADAL" clId="{4EF29121-3155-482A-B3B6-A177FB547C8B}" dt="2024-01-03T19:54:16.357" v="437" actId="1076"/>
      <pc:docMkLst>
        <pc:docMk/>
      </pc:docMkLst>
      <pc:sldChg chg="addSp delSp modSp mod">
        <pc:chgData name="Heck, Craig J." userId="d588c584-9c58-4480-93d4-d317c75b1e10" providerId="ADAL" clId="{4EF29121-3155-482A-B3B6-A177FB547C8B}" dt="2024-01-03T19:54:16.357" v="437" actId="1076"/>
        <pc:sldMkLst>
          <pc:docMk/>
          <pc:sldMk cId="3346016311" sldId="256"/>
        </pc:sldMkLst>
        <pc:spChg chg="mod">
          <ac:chgData name="Heck, Craig J." userId="d588c584-9c58-4480-93d4-d317c75b1e10" providerId="ADAL" clId="{4EF29121-3155-482A-B3B6-A177FB547C8B}" dt="2024-01-03T19:54:16.357" v="437" actId="1076"/>
          <ac:spMkLst>
            <pc:docMk/>
            <pc:sldMk cId="3346016311" sldId="256"/>
            <ac:spMk id="2" creationId="{DAAABFA2-A5C7-650B-7693-540B6238456B}"/>
          </ac:spMkLst>
        </pc:spChg>
        <pc:spChg chg="add mod">
          <ac:chgData name="Heck, Craig J." userId="d588c584-9c58-4480-93d4-d317c75b1e10" providerId="ADAL" clId="{4EF29121-3155-482A-B3B6-A177FB547C8B}" dt="2024-01-03T19:53:49.774" v="400" actId="1076"/>
          <ac:spMkLst>
            <pc:docMk/>
            <pc:sldMk cId="3346016311" sldId="256"/>
            <ac:spMk id="3" creationId="{172A062B-0F71-09B9-5DBD-D86AC13510B8}"/>
          </ac:spMkLst>
        </pc:spChg>
        <pc:spChg chg="add del mod">
          <ac:chgData name="Heck, Craig J." userId="d588c584-9c58-4480-93d4-d317c75b1e10" providerId="ADAL" clId="{4EF29121-3155-482A-B3B6-A177FB547C8B}" dt="2023-12-20T15:53:53.143" v="18" actId="478"/>
          <ac:spMkLst>
            <pc:docMk/>
            <pc:sldMk cId="3346016311" sldId="256"/>
            <ac:spMk id="3" creationId="{5F1467AB-107D-462A-A83E-3E6834808996}"/>
          </ac:spMkLst>
        </pc:spChg>
        <pc:spChg chg="add del 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4" creationId="{CE847D5E-98DD-8B13-F2A9-D6A5770CECC2}"/>
          </ac:spMkLst>
        </pc:spChg>
        <pc:spChg chg="add del 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5" creationId="{2F85BFE0-0E20-0D9C-867C-AEDAC0928AE8}"/>
          </ac:spMkLst>
        </pc:spChg>
        <pc:spChg chg="add del 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6" creationId="{C07F3EBF-8EE4-66A1-15F3-A40111E8385F}"/>
          </ac:spMkLst>
        </pc:spChg>
        <pc:spChg chg="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7" creationId="{9482AA27-768B-D660-CC6C-9D9A7362B15C}"/>
          </ac:spMkLst>
        </pc:spChg>
        <pc:spChg chg="add del 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8" creationId="{C77775BA-D8E5-EB6C-DF0F-5967B4323E99}"/>
          </ac:spMkLst>
        </pc:spChg>
        <pc:spChg chg="add del mod">
          <ac:chgData name="Heck, Craig J." userId="d588c584-9c58-4480-93d4-d317c75b1e10" providerId="ADAL" clId="{4EF29121-3155-482A-B3B6-A177FB547C8B}" dt="2023-12-20T15:53:51.343" v="16" actId="478"/>
          <ac:spMkLst>
            <pc:docMk/>
            <pc:sldMk cId="3346016311" sldId="256"/>
            <ac:spMk id="9" creationId="{8D8956EA-CB0C-3B06-8E70-6741547FAE33}"/>
          </ac:spMkLst>
        </pc:spChg>
        <pc:spChg chg="del">
          <ac:chgData name="Heck, Craig J." userId="d588c584-9c58-4480-93d4-d317c75b1e10" providerId="ADAL" clId="{4EF29121-3155-482A-B3B6-A177FB547C8B}" dt="2023-12-20T15:53:49.175" v="15" actId="478"/>
          <ac:spMkLst>
            <pc:docMk/>
            <pc:sldMk cId="3346016311" sldId="256"/>
            <ac:spMk id="10" creationId="{53EFA8A5-2D2B-B3F2-14AF-783D05ABA51C}"/>
          </ac:spMkLst>
        </pc:spChg>
        <pc:spChg chg="del">
          <ac:chgData name="Heck, Craig J." userId="d588c584-9c58-4480-93d4-d317c75b1e10" providerId="ADAL" clId="{4EF29121-3155-482A-B3B6-A177FB547C8B}" dt="2023-12-20T15:53:44.237" v="13" actId="478"/>
          <ac:spMkLst>
            <pc:docMk/>
            <pc:sldMk cId="3346016311" sldId="256"/>
            <ac:spMk id="11" creationId="{43C093E3-ED83-4C1F-3BC9-242DF6CE805F}"/>
          </ac:spMkLst>
        </pc:spChg>
        <pc:spChg chg="del">
          <ac:chgData name="Heck, Craig J." userId="d588c584-9c58-4480-93d4-d317c75b1e10" providerId="ADAL" clId="{4EF29121-3155-482A-B3B6-A177FB547C8B}" dt="2023-12-20T15:53:39.664" v="9" actId="478"/>
          <ac:spMkLst>
            <pc:docMk/>
            <pc:sldMk cId="3346016311" sldId="256"/>
            <ac:spMk id="12" creationId="{E469ABE4-0822-0599-71E9-07ECD6C65227}"/>
          </ac:spMkLst>
        </pc:spChg>
        <pc:spChg chg="add del 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13" creationId="{D64BC41F-0B79-0578-4B4B-C98ABFCB3BCC}"/>
          </ac:spMkLst>
        </pc:spChg>
        <pc:spChg chg="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14" creationId="{4A7CC871-0903-8025-E7B9-EF4BB72E4454}"/>
          </ac:spMkLst>
        </pc:spChg>
        <pc:spChg chg="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15" creationId="{211FFFF6-37BB-9140-8E27-12A9F323B6F4}"/>
          </ac:spMkLst>
        </pc:spChg>
        <pc:spChg chg="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16" creationId="{0FB714EE-0BF2-4B71-6108-84F56679AB20}"/>
          </ac:spMkLst>
        </pc:spChg>
        <pc:spChg chg="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17" creationId="{B347BE4E-6D05-7526-E0DF-AF0E22F88847}"/>
          </ac:spMkLst>
        </pc:spChg>
        <pc:spChg chg="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18" creationId="{7CCF5A7A-C449-0F33-B30E-D9A6D20BFFBC}"/>
          </ac:spMkLst>
        </pc:spChg>
        <pc:spChg chg="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19" creationId="{0EF7A2EB-353A-82C0-AE9B-0F2891552612}"/>
          </ac:spMkLst>
        </pc:spChg>
        <pc:spChg chg="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20" creationId="{1985846D-99A9-F472-5EF5-7771CFC56C28}"/>
          </ac:spMkLst>
        </pc:spChg>
        <pc:spChg chg="mod">
          <ac:chgData name="Heck, Craig J." userId="d588c584-9c58-4480-93d4-d317c75b1e10" providerId="ADAL" clId="{4EF29121-3155-482A-B3B6-A177FB547C8B}" dt="2024-01-03T19:53:43.485" v="399" actId="1036"/>
          <ac:spMkLst>
            <pc:docMk/>
            <pc:sldMk cId="3346016311" sldId="256"/>
            <ac:spMk id="21" creationId="{5FA9A6CC-3487-981C-7DAD-B42F2409833C}"/>
          </ac:spMkLst>
        </pc:spChg>
        <pc:spChg chg="add del mod">
          <ac:chgData name="Heck, Craig J." userId="d588c584-9c58-4480-93d4-d317c75b1e10" providerId="ADAL" clId="{4EF29121-3155-482A-B3B6-A177FB547C8B}" dt="2023-12-20T15:53:45.931" v="14" actId="478"/>
          <ac:spMkLst>
            <pc:docMk/>
            <pc:sldMk cId="3346016311" sldId="256"/>
            <ac:spMk id="22" creationId="{282AF271-3554-B68B-F7E9-B4C7297CC9C1}"/>
          </ac:spMkLst>
        </pc:spChg>
        <pc:spChg chg="add del mod">
          <ac:chgData name="Heck, Craig J." userId="d588c584-9c58-4480-93d4-d317c75b1e10" providerId="ADAL" clId="{4EF29121-3155-482A-B3B6-A177FB547C8B}" dt="2023-12-20T15:57:22.004" v="46" actId="478"/>
          <ac:spMkLst>
            <pc:docMk/>
            <pc:sldMk cId="3346016311" sldId="256"/>
            <ac:spMk id="23" creationId="{4DC36835-B20F-C172-DA41-79BC36EAE1A2}"/>
          </ac:spMkLst>
        </pc:spChg>
        <pc:spChg chg="add del mod">
          <ac:chgData name="Heck, Craig J." userId="d588c584-9c58-4480-93d4-d317c75b1e10" providerId="ADAL" clId="{4EF29121-3155-482A-B3B6-A177FB547C8B}" dt="2023-12-20T15:57:19.833" v="43" actId="478"/>
          <ac:spMkLst>
            <pc:docMk/>
            <pc:sldMk cId="3346016311" sldId="256"/>
            <ac:spMk id="24" creationId="{8A332F5C-3F44-97E2-41F2-FF9C1B727ACD}"/>
          </ac:spMkLst>
        </pc:spChg>
        <pc:spChg chg="add del mod">
          <ac:chgData name="Heck, Craig J." userId="d588c584-9c58-4480-93d4-d317c75b1e10" providerId="ADAL" clId="{4EF29121-3155-482A-B3B6-A177FB547C8B}" dt="2023-12-20T15:57:20.135" v="44" actId="478"/>
          <ac:spMkLst>
            <pc:docMk/>
            <pc:sldMk cId="3346016311" sldId="256"/>
            <ac:spMk id="25" creationId="{37750E9A-7A9C-0D44-62F4-61B0759925E6}"/>
          </ac:spMkLst>
        </pc:spChg>
        <pc:spChg chg="del mod">
          <ac:chgData name="Heck, Craig J." userId="d588c584-9c58-4480-93d4-d317c75b1e10" providerId="ADAL" clId="{4EF29121-3155-482A-B3B6-A177FB547C8B}" dt="2023-12-20T15:57:20.744" v="45" actId="478"/>
          <ac:spMkLst>
            <pc:docMk/>
            <pc:sldMk cId="3346016311" sldId="256"/>
            <ac:spMk id="26" creationId="{89FF6CF0-610E-C727-465F-F55743111C78}"/>
          </ac:spMkLst>
        </pc:spChg>
        <pc:spChg chg="del">
          <ac:chgData name="Heck, Craig J." userId="d588c584-9c58-4480-93d4-d317c75b1e10" providerId="ADAL" clId="{4EF29121-3155-482A-B3B6-A177FB547C8B}" dt="2023-12-20T15:53:42.846" v="12" actId="478"/>
          <ac:spMkLst>
            <pc:docMk/>
            <pc:sldMk cId="3346016311" sldId="256"/>
            <ac:spMk id="27" creationId="{1A533C97-CF2B-7F4F-EF86-52F2245375FF}"/>
          </ac:spMkLst>
        </pc:spChg>
        <pc:spChg chg="add del mod">
          <ac:chgData name="Heck, Craig J." userId="d588c584-9c58-4480-93d4-d317c75b1e10" providerId="ADAL" clId="{4EF29121-3155-482A-B3B6-A177FB547C8B}" dt="2023-12-20T15:57:23.476" v="47" actId="478"/>
          <ac:spMkLst>
            <pc:docMk/>
            <pc:sldMk cId="3346016311" sldId="256"/>
            <ac:spMk id="28" creationId="{40B08845-6EF4-D1BD-9F20-06BEFE1E46EB}"/>
          </ac:spMkLst>
        </pc:spChg>
        <pc:spChg chg="add mod">
          <ac:chgData name="Heck, Craig J." userId="d588c584-9c58-4480-93d4-d317c75b1e10" providerId="ADAL" clId="{4EF29121-3155-482A-B3B6-A177FB547C8B}" dt="2023-12-20T15:56:56.096" v="38" actId="571"/>
          <ac:spMkLst>
            <pc:docMk/>
            <pc:sldMk cId="3346016311" sldId="256"/>
            <ac:spMk id="29" creationId="{B7AE6030-0E1A-DAD9-F482-8A2996EFF58C}"/>
          </ac:spMkLst>
        </pc:spChg>
        <pc:spChg chg="add mod">
          <ac:chgData name="Heck, Craig J." userId="d588c584-9c58-4480-93d4-d317c75b1e10" providerId="ADAL" clId="{4EF29121-3155-482A-B3B6-A177FB547C8B}" dt="2023-12-20T15:56:56.096" v="38" actId="571"/>
          <ac:spMkLst>
            <pc:docMk/>
            <pc:sldMk cId="3346016311" sldId="256"/>
            <ac:spMk id="30" creationId="{A19B1A71-79C8-98AA-5220-EFBD3FFE4425}"/>
          </ac:spMkLst>
        </pc:spChg>
        <pc:spChg chg="add mod">
          <ac:chgData name="Heck, Craig J." userId="d588c584-9c58-4480-93d4-d317c75b1e10" providerId="ADAL" clId="{4EF29121-3155-482A-B3B6-A177FB547C8B}" dt="2023-12-20T15:56:56.096" v="38" actId="571"/>
          <ac:spMkLst>
            <pc:docMk/>
            <pc:sldMk cId="3346016311" sldId="256"/>
            <ac:spMk id="31" creationId="{47F74A19-0CD2-0B3C-F913-8709CE313E1D}"/>
          </ac:spMkLst>
        </pc:spChg>
        <pc:cxnChg chg="add mo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33" creationId="{64C59D0C-1982-3ABC-AB32-1CA76BC3259B}"/>
          </ac:cxnSpMkLst>
        </pc:cxnChg>
        <pc:cxnChg chg="add mo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35" creationId="{5550D74B-9196-80D5-D500-A17929C16779}"/>
          </ac:cxnSpMkLst>
        </pc:cxnChg>
        <pc:cxnChg chg="add mo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37" creationId="{393F913A-2C32-3633-24A4-92353C6CF03D}"/>
          </ac:cxnSpMkLst>
        </pc:cxnChg>
        <pc:cxnChg chg="add mo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39" creationId="{598B53BB-00F8-959E-EF82-83461AE9FBBE}"/>
          </ac:cxnSpMkLst>
        </pc:cxnChg>
        <pc:cxnChg chg="add mo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41" creationId="{50738FAE-658F-2286-7062-90318DCC0745}"/>
          </ac:cxnSpMkLst>
        </pc:cxnChg>
        <pc:cxnChg chg="add mod or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54" creationId="{F16AB3AD-4C30-ADDB-7FAF-99B20565E882}"/>
          </ac:cxnSpMkLst>
        </pc:cxnChg>
        <pc:cxnChg chg="add mod or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56" creationId="{CBB05C36-4913-11C8-AF5D-9847B673433E}"/>
          </ac:cxnSpMkLst>
        </pc:cxnChg>
        <pc:cxnChg chg="add mod or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57" creationId="{49169690-802F-32A7-5AA7-83737786F2DC}"/>
          </ac:cxnSpMkLst>
        </pc:cxnChg>
        <pc:cxnChg chg="add mod or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58" creationId="{11F7525C-CBC3-1449-8AF7-B4239D1710FF}"/>
          </ac:cxnSpMkLst>
        </pc:cxnChg>
        <pc:cxnChg chg="add mod ord">
          <ac:chgData name="Heck, Craig J." userId="d588c584-9c58-4480-93d4-d317c75b1e10" providerId="ADAL" clId="{4EF29121-3155-482A-B3B6-A177FB547C8B}" dt="2024-01-03T19:53:43.485" v="399" actId="1036"/>
          <ac:cxnSpMkLst>
            <pc:docMk/>
            <pc:sldMk cId="3346016311" sldId="256"/>
            <ac:cxnSpMk id="59" creationId="{8353033B-1582-7585-8AB0-CA9B1BFABE6B}"/>
          </ac:cxnSpMkLst>
        </pc:cxnChg>
      </pc:sldChg>
      <pc:sldMasterChg chg="modSp modSldLayout">
        <pc:chgData name="Heck, Craig J." userId="d588c584-9c58-4480-93d4-d317c75b1e10" providerId="ADAL" clId="{4EF29121-3155-482A-B3B6-A177FB547C8B}" dt="2024-01-03T19:52:24.193" v="224"/>
        <pc:sldMasterMkLst>
          <pc:docMk/>
          <pc:sldMasterMk cId="936471170" sldId="2147483660"/>
        </pc:sldMasterMkLst>
        <pc:spChg chg="mod">
          <ac:chgData name="Heck, Craig J." userId="d588c584-9c58-4480-93d4-d317c75b1e10" providerId="ADAL" clId="{4EF29121-3155-482A-B3B6-A177FB547C8B}" dt="2024-01-03T19:52:24.193" v="224"/>
          <ac:spMkLst>
            <pc:docMk/>
            <pc:sldMasterMk cId="936471170" sldId="2147483660"/>
            <ac:spMk id="2" creationId="{00000000-0000-0000-0000-000000000000}"/>
          </ac:spMkLst>
        </pc:spChg>
        <pc:spChg chg="mod">
          <ac:chgData name="Heck, Craig J." userId="d588c584-9c58-4480-93d4-d317c75b1e10" providerId="ADAL" clId="{4EF29121-3155-482A-B3B6-A177FB547C8B}" dt="2024-01-03T19:52:24.193" v="224"/>
          <ac:spMkLst>
            <pc:docMk/>
            <pc:sldMasterMk cId="936471170" sldId="2147483660"/>
            <ac:spMk id="3" creationId="{00000000-0000-0000-0000-000000000000}"/>
          </ac:spMkLst>
        </pc:spChg>
        <pc:spChg chg="mod">
          <ac:chgData name="Heck, Craig J." userId="d588c584-9c58-4480-93d4-d317c75b1e10" providerId="ADAL" clId="{4EF29121-3155-482A-B3B6-A177FB547C8B}" dt="2024-01-03T19:52:24.193" v="224"/>
          <ac:spMkLst>
            <pc:docMk/>
            <pc:sldMasterMk cId="936471170" sldId="2147483660"/>
            <ac:spMk id="4" creationId="{00000000-0000-0000-0000-000000000000}"/>
          </ac:spMkLst>
        </pc:spChg>
        <pc:spChg chg="mod">
          <ac:chgData name="Heck, Craig J." userId="d588c584-9c58-4480-93d4-d317c75b1e10" providerId="ADAL" clId="{4EF29121-3155-482A-B3B6-A177FB547C8B}" dt="2024-01-03T19:52:24.193" v="224"/>
          <ac:spMkLst>
            <pc:docMk/>
            <pc:sldMasterMk cId="936471170" sldId="2147483660"/>
            <ac:spMk id="5" creationId="{00000000-0000-0000-0000-000000000000}"/>
          </ac:spMkLst>
        </pc:spChg>
        <pc:spChg chg="mod">
          <ac:chgData name="Heck, Craig J." userId="d588c584-9c58-4480-93d4-d317c75b1e10" providerId="ADAL" clId="{4EF29121-3155-482A-B3B6-A177FB547C8B}" dt="2024-01-03T19:52:24.193" v="224"/>
          <ac:spMkLst>
            <pc:docMk/>
            <pc:sldMasterMk cId="936471170" sldId="2147483660"/>
            <ac:spMk id="6" creationId="{00000000-0000-0000-0000-000000000000}"/>
          </ac:spMkLst>
        </pc:spChg>
        <pc:sldLayoutChg chg="modSp">
          <pc:chgData name="Heck, Craig J." userId="d588c584-9c58-4480-93d4-d317c75b1e10" providerId="ADAL" clId="{4EF29121-3155-482A-B3B6-A177FB547C8B}" dt="2024-01-03T19:52:24.193" v="224"/>
          <pc:sldLayoutMkLst>
            <pc:docMk/>
            <pc:sldMasterMk cId="936471170" sldId="2147483660"/>
            <pc:sldLayoutMk cId="3821344272" sldId="2147483661"/>
          </pc:sldLayoutMkLst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3821344272" sldId="2147483661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3821344272" sldId="2147483661"/>
              <ac:spMk id="3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2:24.193" v="224"/>
          <pc:sldLayoutMkLst>
            <pc:docMk/>
            <pc:sldMasterMk cId="936471170" sldId="2147483660"/>
            <pc:sldLayoutMk cId="1113992729" sldId="2147483663"/>
          </pc:sldLayoutMkLst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1113992729" sldId="2147483663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1113992729" sldId="2147483663"/>
              <ac:spMk id="3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2:24.193" v="224"/>
          <pc:sldLayoutMkLst>
            <pc:docMk/>
            <pc:sldMasterMk cId="936471170" sldId="2147483660"/>
            <pc:sldLayoutMk cId="1930102444" sldId="2147483664"/>
          </pc:sldLayoutMkLst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1930102444" sldId="2147483664"/>
              <ac:spMk id="3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1930102444" sldId="2147483664"/>
              <ac:spMk id="4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2:24.193" v="224"/>
          <pc:sldLayoutMkLst>
            <pc:docMk/>
            <pc:sldMasterMk cId="936471170" sldId="2147483660"/>
            <pc:sldLayoutMk cId="1135648648" sldId="2147483665"/>
          </pc:sldLayoutMkLst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1135648648" sldId="2147483665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1135648648" sldId="2147483665"/>
              <ac:spMk id="3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1135648648" sldId="2147483665"/>
              <ac:spMk id="4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1135648648" sldId="2147483665"/>
              <ac:spMk id="5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1135648648" sldId="2147483665"/>
              <ac:spMk id="6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2:24.193" v="224"/>
          <pc:sldLayoutMkLst>
            <pc:docMk/>
            <pc:sldMasterMk cId="936471170" sldId="2147483660"/>
            <pc:sldLayoutMk cId="2054233106" sldId="2147483668"/>
          </pc:sldLayoutMkLst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2054233106" sldId="2147483668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2054233106" sldId="2147483668"/>
              <ac:spMk id="3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2054233106" sldId="2147483668"/>
              <ac:spMk id="4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2:24.193" v="224"/>
          <pc:sldLayoutMkLst>
            <pc:docMk/>
            <pc:sldMasterMk cId="936471170" sldId="2147483660"/>
            <pc:sldLayoutMk cId="4272740469" sldId="2147483669"/>
          </pc:sldLayoutMkLst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4272740469" sldId="2147483669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4272740469" sldId="2147483669"/>
              <ac:spMk id="3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4272740469" sldId="2147483669"/>
              <ac:spMk id="4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2:24.193" v="224"/>
          <pc:sldLayoutMkLst>
            <pc:docMk/>
            <pc:sldMasterMk cId="936471170" sldId="2147483660"/>
            <pc:sldLayoutMk cId="3272689081" sldId="2147483671"/>
          </pc:sldLayoutMkLst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3272689081" sldId="2147483671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2:24.193" v="224"/>
            <ac:spMkLst>
              <pc:docMk/>
              <pc:sldMasterMk cId="936471170" sldId="2147483660"/>
              <pc:sldLayoutMk cId="3272689081" sldId="2147483671"/>
              <ac:spMk id="3" creationId="{00000000-0000-0000-0000-000000000000}"/>
            </ac:spMkLst>
          </pc:spChg>
        </pc:sldLayoutChg>
      </pc:sldMasterChg>
      <pc:sldMasterChg chg="modSp modSldLayout">
        <pc:chgData name="Heck, Craig J." userId="d588c584-9c58-4480-93d4-d317c75b1e10" providerId="ADAL" clId="{4EF29121-3155-482A-B3B6-A177FB547C8B}" dt="2024-01-03T19:53:22.235" v="339"/>
        <pc:sldMasterMkLst>
          <pc:docMk/>
          <pc:sldMasterMk cId="1267098813" sldId="2147483672"/>
        </pc:sldMasterMkLst>
        <pc:spChg chg="mod">
          <ac:chgData name="Heck, Craig J." userId="d588c584-9c58-4480-93d4-d317c75b1e10" providerId="ADAL" clId="{4EF29121-3155-482A-B3B6-A177FB547C8B}" dt="2024-01-03T19:53:22.235" v="339"/>
          <ac:spMkLst>
            <pc:docMk/>
            <pc:sldMasterMk cId="1267098813" sldId="2147483672"/>
            <ac:spMk id="2" creationId="{00000000-0000-0000-0000-000000000000}"/>
          </ac:spMkLst>
        </pc:spChg>
        <pc:spChg chg="mod">
          <ac:chgData name="Heck, Craig J." userId="d588c584-9c58-4480-93d4-d317c75b1e10" providerId="ADAL" clId="{4EF29121-3155-482A-B3B6-A177FB547C8B}" dt="2024-01-03T19:53:22.235" v="339"/>
          <ac:spMkLst>
            <pc:docMk/>
            <pc:sldMasterMk cId="1267098813" sldId="2147483672"/>
            <ac:spMk id="3" creationId="{00000000-0000-0000-0000-000000000000}"/>
          </ac:spMkLst>
        </pc:spChg>
        <pc:spChg chg="mod">
          <ac:chgData name="Heck, Craig J." userId="d588c584-9c58-4480-93d4-d317c75b1e10" providerId="ADAL" clId="{4EF29121-3155-482A-B3B6-A177FB547C8B}" dt="2024-01-03T19:53:22.235" v="339"/>
          <ac:spMkLst>
            <pc:docMk/>
            <pc:sldMasterMk cId="1267098813" sldId="2147483672"/>
            <ac:spMk id="4" creationId="{00000000-0000-0000-0000-000000000000}"/>
          </ac:spMkLst>
        </pc:spChg>
        <pc:spChg chg="mod">
          <ac:chgData name="Heck, Craig J." userId="d588c584-9c58-4480-93d4-d317c75b1e10" providerId="ADAL" clId="{4EF29121-3155-482A-B3B6-A177FB547C8B}" dt="2024-01-03T19:53:22.235" v="339"/>
          <ac:spMkLst>
            <pc:docMk/>
            <pc:sldMasterMk cId="1267098813" sldId="2147483672"/>
            <ac:spMk id="5" creationId="{00000000-0000-0000-0000-000000000000}"/>
          </ac:spMkLst>
        </pc:spChg>
        <pc:spChg chg="mod">
          <ac:chgData name="Heck, Craig J." userId="d588c584-9c58-4480-93d4-d317c75b1e10" providerId="ADAL" clId="{4EF29121-3155-482A-B3B6-A177FB547C8B}" dt="2024-01-03T19:53:22.235" v="339"/>
          <ac:spMkLst>
            <pc:docMk/>
            <pc:sldMasterMk cId="1267098813" sldId="2147483672"/>
            <ac:spMk id="6" creationId="{00000000-0000-0000-0000-000000000000}"/>
          </ac:spMkLst>
        </pc:spChg>
        <pc:sldLayoutChg chg="modSp">
          <pc:chgData name="Heck, Craig J." userId="d588c584-9c58-4480-93d4-d317c75b1e10" providerId="ADAL" clId="{4EF29121-3155-482A-B3B6-A177FB547C8B}" dt="2024-01-03T19:53:22.235" v="339"/>
          <pc:sldLayoutMkLst>
            <pc:docMk/>
            <pc:sldMasterMk cId="1267098813" sldId="2147483672"/>
            <pc:sldLayoutMk cId="405523199" sldId="2147483673"/>
          </pc:sldLayoutMkLst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405523199" sldId="2147483673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405523199" sldId="2147483673"/>
              <ac:spMk id="3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3:22.235" v="339"/>
          <pc:sldLayoutMkLst>
            <pc:docMk/>
            <pc:sldMasterMk cId="1267098813" sldId="2147483672"/>
            <pc:sldLayoutMk cId="2036283000" sldId="2147483675"/>
          </pc:sldLayoutMkLst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2036283000" sldId="2147483675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2036283000" sldId="2147483675"/>
              <ac:spMk id="3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3:22.235" v="339"/>
          <pc:sldLayoutMkLst>
            <pc:docMk/>
            <pc:sldMasterMk cId="1267098813" sldId="2147483672"/>
            <pc:sldLayoutMk cId="2212140066" sldId="2147483676"/>
          </pc:sldLayoutMkLst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2212140066" sldId="2147483676"/>
              <ac:spMk id="3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2212140066" sldId="2147483676"/>
              <ac:spMk id="4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3:22.235" v="339"/>
          <pc:sldLayoutMkLst>
            <pc:docMk/>
            <pc:sldMasterMk cId="1267098813" sldId="2147483672"/>
            <pc:sldLayoutMk cId="955348244" sldId="2147483677"/>
          </pc:sldLayoutMkLst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955348244" sldId="2147483677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955348244" sldId="2147483677"/>
              <ac:spMk id="3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955348244" sldId="2147483677"/>
              <ac:spMk id="4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955348244" sldId="2147483677"/>
              <ac:spMk id="5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955348244" sldId="2147483677"/>
              <ac:spMk id="6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3:22.235" v="339"/>
          <pc:sldLayoutMkLst>
            <pc:docMk/>
            <pc:sldMasterMk cId="1267098813" sldId="2147483672"/>
            <pc:sldLayoutMk cId="1301204266" sldId="2147483680"/>
          </pc:sldLayoutMkLst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1301204266" sldId="2147483680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1301204266" sldId="2147483680"/>
              <ac:spMk id="3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1301204266" sldId="2147483680"/>
              <ac:spMk id="4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3:22.235" v="339"/>
          <pc:sldLayoutMkLst>
            <pc:docMk/>
            <pc:sldMasterMk cId="1267098813" sldId="2147483672"/>
            <pc:sldLayoutMk cId="3421476960" sldId="2147483681"/>
          </pc:sldLayoutMkLst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3421476960" sldId="2147483681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3421476960" sldId="2147483681"/>
              <ac:spMk id="3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3421476960" sldId="2147483681"/>
              <ac:spMk id="4" creationId="{00000000-0000-0000-0000-000000000000}"/>
            </ac:spMkLst>
          </pc:spChg>
        </pc:sldLayoutChg>
        <pc:sldLayoutChg chg="modSp">
          <pc:chgData name="Heck, Craig J." userId="d588c584-9c58-4480-93d4-d317c75b1e10" providerId="ADAL" clId="{4EF29121-3155-482A-B3B6-A177FB547C8B}" dt="2024-01-03T19:53:22.235" v="339"/>
          <pc:sldLayoutMkLst>
            <pc:docMk/>
            <pc:sldMasterMk cId="1267098813" sldId="2147483672"/>
            <pc:sldLayoutMk cId="198221931" sldId="2147483683"/>
          </pc:sldLayoutMkLst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198221931" sldId="2147483683"/>
              <ac:spMk id="2" creationId="{00000000-0000-0000-0000-000000000000}"/>
            </ac:spMkLst>
          </pc:spChg>
          <pc:spChg chg="mod">
            <ac:chgData name="Heck, Craig J." userId="d588c584-9c58-4480-93d4-d317c75b1e10" providerId="ADAL" clId="{4EF29121-3155-482A-B3B6-A177FB547C8B}" dt="2024-01-03T19:53:22.235" v="339"/>
            <ac:spMkLst>
              <pc:docMk/>
              <pc:sldMasterMk cId="1267098813" sldId="2147483672"/>
              <pc:sldLayoutMk cId="198221931" sldId="2147483683"/>
              <ac:spMk id="3" creationId="{00000000-0000-0000-0000-000000000000}"/>
            </ac:spMkLst>
          </pc:spChg>
        </pc:sldLayoutChg>
      </pc:sldMasterChg>
    </pc:docChg>
  </pc:docChgLst>
  <pc:docChgLst>
    <pc:chgData name="Craig Heck" userId="e1fb993239fb696d" providerId="LiveId" clId="{FEF7A0BD-402F-4A94-BB00-C54B45E4D826}"/>
    <pc:docChg chg="undo custSel addSld modSld">
      <pc:chgData name="Craig Heck" userId="e1fb993239fb696d" providerId="LiveId" clId="{FEF7A0BD-402F-4A94-BB00-C54B45E4D826}" dt="2023-09-25T14:11:29.864" v="939" actId="1076"/>
      <pc:docMkLst>
        <pc:docMk/>
      </pc:docMkLst>
      <pc:sldChg chg="addSp delSp modSp new mod">
        <pc:chgData name="Craig Heck" userId="e1fb993239fb696d" providerId="LiveId" clId="{FEF7A0BD-402F-4A94-BB00-C54B45E4D826}" dt="2023-09-25T14:11:29.864" v="939" actId="1076"/>
        <pc:sldMkLst>
          <pc:docMk/>
          <pc:sldMk cId="3346016311" sldId="256"/>
        </pc:sldMkLst>
        <pc:spChg chg="del">
          <ac:chgData name="Craig Heck" userId="e1fb993239fb696d" providerId="LiveId" clId="{FEF7A0BD-402F-4A94-BB00-C54B45E4D826}" dt="2023-09-22T17:10:47.778" v="1" actId="478"/>
          <ac:spMkLst>
            <pc:docMk/>
            <pc:sldMk cId="3346016311" sldId="256"/>
            <ac:spMk id="2" creationId="{7A1DEB78-EABB-3D2F-A795-2E3EA3FABFB0}"/>
          </ac:spMkLst>
        </pc:spChg>
        <pc:spChg chg="add mod">
          <ac:chgData name="Craig Heck" userId="e1fb993239fb696d" providerId="LiveId" clId="{FEF7A0BD-402F-4A94-BB00-C54B45E4D826}" dt="2023-09-25T14:11:17.301" v="938" actId="20577"/>
          <ac:spMkLst>
            <pc:docMk/>
            <pc:sldMk cId="3346016311" sldId="256"/>
            <ac:spMk id="2" creationId="{DAAABFA2-A5C7-650B-7693-540B6238456B}"/>
          </ac:spMkLst>
        </pc:spChg>
        <pc:spChg chg="del">
          <ac:chgData name="Craig Heck" userId="e1fb993239fb696d" providerId="LiveId" clId="{FEF7A0BD-402F-4A94-BB00-C54B45E4D826}" dt="2023-09-22T17:10:49.050" v="2" actId="478"/>
          <ac:spMkLst>
            <pc:docMk/>
            <pc:sldMk cId="3346016311" sldId="256"/>
            <ac:spMk id="3" creationId="{B9A07C2D-7C57-B675-0B83-4E62AA5A5064}"/>
          </ac:spMkLst>
        </pc:spChg>
        <pc:spChg chg="add del mod">
          <ac:chgData name="Craig Heck" userId="e1fb993239fb696d" providerId="LiveId" clId="{FEF7A0BD-402F-4A94-BB00-C54B45E4D826}" dt="2023-09-22T17:27:28.248" v="197" actId="478"/>
          <ac:spMkLst>
            <pc:docMk/>
            <pc:sldMk cId="3346016311" sldId="256"/>
            <ac:spMk id="4" creationId="{11A2DFD0-0465-B027-1DC7-A83FDF4CB1CE}"/>
          </ac:spMkLst>
        </pc:spChg>
        <pc:spChg chg="add del mod">
          <ac:chgData name="Craig Heck" userId="e1fb993239fb696d" providerId="LiveId" clId="{FEF7A0BD-402F-4A94-BB00-C54B45E4D826}" dt="2023-09-22T17:27:27.839" v="196" actId="478"/>
          <ac:spMkLst>
            <pc:docMk/>
            <pc:sldMk cId="3346016311" sldId="256"/>
            <ac:spMk id="5" creationId="{3B8A911D-3C2B-CE13-FB02-C6E8E1337A0E}"/>
          </ac:spMkLst>
        </pc:spChg>
        <pc:spChg chg="add del mod">
          <ac:chgData name="Craig Heck" userId="e1fb993239fb696d" providerId="LiveId" clId="{FEF7A0BD-402F-4A94-BB00-C54B45E4D826}" dt="2023-09-22T18:22:14.710" v="613" actId="478"/>
          <ac:spMkLst>
            <pc:docMk/>
            <pc:sldMk cId="3346016311" sldId="256"/>
            <ac:spMk id="6" creationId="{C06DBFD5-733A-5372-99A2-B4E678D853F5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7" creationId="{9482AA27-768B-D660-CC6C-9D9A7362B15C}"/>
          </ac:spMkLst>
        </pc:spChg>
        <pc:spChg chg="add del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8" creationId="{C77775BA-D8E5-EB6C-DF0F-5967B4323E99}"/>
          </ac:spMkLst>
        </pc:spChg>
        <pc:spChg chg="add del mod">
          <ac:chgData name="Craig Heck" userId="e1fb993239fb696d" providerId="LiveId" clId="{FEF7A0BD-402F-4A94-BB00-C54B45E4D826}" dt="2023-09-22T18:22:13.229" v="612" actId="478"/>
          <ac:spMkLst>
            <pc:docMk/>
            <pc:sldMk cId="3346016311" sldId="256"/>
            <ac:spMk id="9" creationId="{5F35E93E-6486-F469-323B-8E2BA559B149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10" creationId="{53EFA8A5-2D2B-B3F2-14AF-783D05ABA51C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11" creationId="{43C093E3-ED83-4C1F-3BC9-242DF6CE805F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12" creationId="{E469ABE4-0822-0599-71E9-07ECD6C65227}"/>
          </ac:spMkLst>
        </pc:spChg>
        <pc:spChg chg="add mod">
          <ac:chgData name="Craig Heck" userId="e1fb993239fb696d" providerId="LiveId" clId="{FEF7A0BD-402F-4A94-BB00-C54B45E4D826}" dt="2023-09-25T14:11:29.864" v="939" actId="1076"/>
          <ac:spMkLst>
            <pc:docMk/>
            <pc:sldMk cId="3346016311" sldId="256"/>
            <ac:spMk id="13" creationId="{D64BC41F-0B79-0578-4B4B-C98ABFCB3BCC}"/>
          </ac:spMkLst>
        </pc:spChg>
        <pc:spChg chg="add del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14" creationId="{4A7CC871-0903-8025-E7B9-EF4BB72E4454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15" creationId="{211FFFF6-37BB-9140-8E27-12A9F323B6F4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16" creationId="{0FB714EE-0BF2-4B71-6108-84F56679AB20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17" creationId="{B347BE4E-6D05-7526-E0DF-AF0E22F88847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18" creationId="{7CCF5A7A-C449-0F33-B30E-D9A6D20BFFBC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19" creationId="{0EF7A2EB-353A-82C0-AE9B-0F2891552612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20" creationId="{1985846D-99A9-F472-5EF5-7771CFC56C28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21" creationId="{5FA9A6CC-3487-981C-7DAD-B42F2409833C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24" creationId="{8A332F5C-3F44-97E2-41F2-FF9C1B727ACD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25" creationId="{37750E9A-7A9C-0D44-62F4-61B0759925E6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26" creationId="{89FF6CF0-610E-C727-465F-F55743111C78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27" creationId="{1A533C97-CF2B-7F4F-EF86-52F2245375FF}"/>
          </ac:spMkLst>
        </pc:spChg>
        <pc:spChg chg="add mod">
          <ac:chgData name="Craig Heck" userId="e1fb993239fb696d" providerId="LiveId" clId="{FEF7A0BD-402F-4A94-BB00-C54B45E4D826}" dt="2023-09-25T14:09:59.833" v="824" actId="1035"/>
          <ac:spMkLst>
            <pc:docMk/>
            <pc:sldMk cId="3346016311" sldId="256"/>
            <ac:spMk id="28" creationId="{40B08845-6EF4-D1BD-9F20-06BEFE1E46EB}"/>
          </ac:spMkLst>
        </pc:spChg>
        <pc:cxnChg chg="add del mod">
          <ac:chgData name="Craig Heck" userId="e1fb993239fb696d" providerId="LiveId" clId="{FEF7A0BD-402F-4A94-BB00-C54B45E4D826}" dt="2023-09-22T19:56:24.975" v="790" actId="11529"/>
          <ac:cxnSpMkLst>
            <pc:docMk/>
            <pc:sldMk cId="3346016311" sldId="256"/>
            <ac:cxnSpMk id="23" creationId="{0B929F9F-8C9D-11DA-CCCB-7BAB4749E9A9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21660"/>
            <a:ext cx="5829300" cy="302429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562581"/>
            <a:ext cx="5143500" cy="2097299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619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358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62492"/>
            <a:ext cx="1478756" cy="736166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62492"/>
            <a:ext cx="4350544" cy="736166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844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90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165670"/>
            <a:ext cx="5915025" cy="361346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813322"/>
            <a:ext cx="5915025" cy="19002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098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12458"/>
            <a:ext cx="2914650" cy="55116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12458"/>
            <a:ext cx="2914650" cy="55116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474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62494"/>
            <a:ext cx="5915025" cy="167904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129473"/>
            <a:ext cx="2901255" cy="10436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173095"/>
            <a:ext cx="2901255" cy="46671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129473"/>
            <a:ext cx="2915543" cy="10436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173095"/>
            <a:ext cx="2915543" cy="466714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137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206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318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9120"/>
            <a:ext cx="2211884" cy="20269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50740"/>
            <a:ext cx="3471863" cy="61732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06040"/>
            <a:ext cx="2211884" cy="482801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225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9120"/>
            <a:ext cx="2211884" cy="20269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50740"/>
            <a:ext cx="3471863" cy="61732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06040"/>
            <a:ext cx="2211884" cy="482801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28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62494"/>
            <a:ext cx="5915025" cy="16790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12458"/>
            <a:ext cx="5915025" cy="551169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051378"/>
            <a:ext cx="154305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68E13-7757-40C5-9440-CC156D921317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051378"/>
            <a:ext cx="2314575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051378"/>
            <a:ext cx="1543050" cy="462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D0B34E-4459-4629-ADD4-A80CF48C5E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690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8353033B-1582-7585-8AB0-CA9B1BFABE6B}"/>
              </a:ext>
            </a:extLst>
          </p:cNvPr>
          <p:cNvCxnSpPr>
            <a:cxnSpLocks/>
          </p:cNvCxnSpPr>
          <p:nvPr/>
        </p:nvCxnSpPr>
        <p:spPr>
          <a:xfrm>
            <a:off x="3429001" y="7490452"/>
            <a:ext cx="103992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11F7525C-CBC3-1449-8AF7-B4239D1710FF}"/>
              </a:ext>
            </a:extLst>
          </p:cNvPr>
          <p:cNvCxnSpPr>
            <a:cxnSpLocks/>
          </p:cNvCxnSpPr>
          <p:nvPr/>
        </p:nvCxnSpPr>
        <p:spPr>
          <a:xfrm>
            <a:off x="3429001" y="6296652"/>
            <a:ext cx="103992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49169690-802F-32A7-5AA7-83737786F2DC}"/>
              </a:ext>
            </a:extLst>
          </p:cNvPr>
          <p:cNvCxnSpPr>
            <a:cxnSpLocks/>
          </p:cNvCxnSpPr>
          <p:nvPr/>
        </p:nvCxnSpPr>
        <p:spPr>
          <a:xfrm>
            <a:off x="3429001" y="5102852"/>
            <a:ext cx="103992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CBB05C36-4913-11C8-AF5D-9847B673433E}"/>
              </a:ext>
            </a:extLst>
          </p:cNvPr>
          <p:cNvCxnSpPr>
            <a:cxnSpLocks/>
          </p:cNvCxnSpPr>
          <p:nvPr/>
        </p:nvCxnSpPr>
        <p:spPr>
          <a:xfrm>
            <a:off x="3429001" y="3914132"/>
            <a:ext cx="103992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F16AB3AD-4C30-ADDB-7FAF-99B20565E882}"/>
              </a:ext>
            </a:extLst>
          </p:cNvPr>
          <p:cNvCxnSpPr>
            <a:cxnSpLocks/>
            <a:endCxn id="19" idx="1"/>
          </p:cNvCxnSpPr>
          <p:nvPr/>
        </p:nvCxnSpPr>
        <p:spPr>
          <a:xfrm>
            <a:off x="3429001" y="2705092"/>
            <a:ext cx="103992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9482AA27-768B-D660-CC6C-9D9A7362B15C}"/>
              </a:ext>
            </a:extLst>
          </p:cNvPr>
          <p:cNvSpPr/>
          <p:nvPr/>
        </p:nvSpPr>
        <p:spPr>
          <a:xfrm>
            <a:off x="685800" y="1485450"/>
            <a:ext cx="5486400" cy="321427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728 eligible individuals provided written informed consent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C77775BA-D8E5-EB6C-DF0F-5967B4323E99}"/>
              </a:ext>
            </a:extLst>
          </p:cNvPr>
          <p:cNvSpPr/>
          <p:nvPr/>
        </p:nvSpPr>
        <p:spPr>
          <a:xfrm>
            <a:off x="2479320" y="3033228"/>
            <a:ext cx="1899360" cy="555187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562 students completed T1 survey</a:t>
            </a:r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D64BC41F-0B79-0578-4B4B-C98ABFCB3BCC}"/>
              </a:ext>
            </a:extLst>
          </p:cNvPr>
          <p:cNvSpPr/>
          <p:nvPr/>
        </p:nvSpPr>
        <p:spPr>
          <a:xfrm>
            <a:off x="2479320" y="7807906"/>
            <a:ext cx="1899360" cy="557784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169 at T4</a:t>
            </a:r>
          </a:p>
        </p:txBody>
      </p:sp>
      <p:sp>
        <p:nvSpPr>
          <p:cNvPr id="14" name="Rectangle: Rounded Corners 13">
            <a:extLst>
              <a:ext uri="{FF2B5EF4-FFF2-40B4-BE49-F238E27FC236}">
                <a16:creationId xmlns:a16="http://schemas.microsoft.com/office/drawing/2014/main" id="{4A7CC871-0903-8025-E7B9-EF4BB72E4454}"/>
              </a:ext>
            </a:extLst>
          </p:cNvPr>
          <p:cNvSpPr/>
          <p:nvPr/>
        </p:nvSpPr>
        <p:spPr>
          <a:xfrm>
            <a:off x="4470643" y="7170976"/>
            <a:ext cx="2311727" cy="642988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49 unresponsive to invite</a:t>
            </a:r>
          </a:p>
          <a:p>
            <a:pPr algn="ctr"/>
            <a:r>
              <a:rPr lang="en-US" sz="1400" dirty="0"/>
              <a:t>2 did not provide T4 PD data</a:t>
            </a:r>
          </a:p>
          <a:p>
            <a:pPr algn="ctr"/>
            <a:r>
              <a:rPr lang="en-US" sz="1400" dirty="0"/>
              <a:t>1 student became staff</a:t>
            </a:r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211FFFF6-37BB-9140-8E27-12A9F323B6F4}"/>
              </a:ext>
            </a:extLst>
          </p:cNvPr>
          <p:cNvSpPr/>
          <p:nvPr/>
        </p:nvSpPr>
        <p:spPr>
          <a:xfrm>
            <a:off x="4468929" y="4784506"/>
            <a:ext cx="2313432" cy="6400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220 unresponsive to invite</a:t>
            </a:r>
          </a:p>
          <a:p>
            <a:pPr algn="ctr"/>
            <a:r>
              <a:rPr lang="en-US" sz="1400" dirty="0"/>
              <a:t>2 did not provide T2 PD data</a:t>
            </a:r>
          </a:p>
        </p:txBody>
      </p:sp>
      <p:sp>
        <p:nvSpPr>
          <p:cNvPr id="16" name="Rectangle: Rounded Corners 15">
            <a:extLst>
              <a:ext uri="{FF2B5EF4-FFF2-40B4-BE49-F238E27FC236}">
                <a16:creationId xmlns:a16="http://schemas.microsoft.com/office/drawing/2014/main" id="{0FB714EE-0BF2-4B71-6108-84F56679AB20}"/>
              </a:ext>
            </a:extLst>
          </p:cNvPr>
          <p:cNvSpPr/>
          <p:nvPr/>
        </p:nvSpPr>
        <p:spPr>
          <a:xfrm>
            <a:off x="4468929" y="5979652"/>
            <a:ext cx="2313432" cy="6400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111 unresponsive to invite</a:t>
            </a:r>
          </a:p>
          <a:p>
            <a:pPr algn="ctr"/>
            <a:r>
              <a:rPr lang="en-US" sz="1400" dirty="0"/>
              <a:t>2 did not provide T3 PD data</a:t>
            </a:r>
          </a:p>
        </p:txBody>
      </p:sp>
      <p:sp>
        <p:nvSpPr>
          <p:cNvPr id="17" name="Rectangle: Rounded Corners 16">
            <a:extLst>
              <a:ext uri="{FF2B5EF4-FFF2-40B4-BE49-F238E27FC236}">
                <a16:creationId xmlns:a16="http://schemas.microsoft.com/office/drawing/2014/main" id="{B347BE4E-6D05-7526-E0DF-AF0E22F88847}"/>
              </a:ext>
            </a:extLst>
          </p:cNvPr>
          <p:cNvSpPr/>
          <p:nvPr/>
        </p:nvSpPr>
        <p:spPr>
          <a:xfrm>
            <a:off x="685800" y="533183"/>
            <a:ext cx="5486400" cy="321427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977 completed the eligibility screener</a:t>
            </a:r>
          </a:p>
        </p:txBody>
      </p: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7CCF5A7A-C449-0F33-B30E-D9A6D20BFFBC}"/>
              </a:ext>
            </a:extLst>
          </p:cNvPr>
          <p:cNvSpPr/>
          <p:nvPr/>
        </p:nvSpPr>
        <p:spPr>
          <a:xfrm>
            <a:off x="685800" y="1956506"/>
            <a:ext cx="5486400" cy="321427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666 completed T1 survey</a:t>
            </a:r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0EF7A2EB-353A-82C0-AE9B-0F2891552612}"/>
              </a:ext>
            </a:extLst>
          </p:cNvPr>
          <p:cNvSpPr/>
          <p:nvPr/>
        </p:nvSpPr>
        <p:spPr>
          <a:xfrm>
            <a:off x="4468929" y="2399648"/>
            <a:ext cx="2313432" cy="6400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35 faculty </a:t>
            </a:r>
          </a:p>
          <a:p>
            <a:pPr algn="ctr"/>
            <a:r>
              <a:rPr lang="en-US" sz="1400" dirty="0"/>
              <a:t>69 staff</a:t>
            </a:r>
          </a:p>
        </p:txBody>
      </p:sp>
      <p:sp>
        <p:nvSpPr>
          <p:cNvPr id="20" name="Rectangle: Rounded Corners 19">
            <a:extLst>
              <a:ext uri="{FF2B5EF4-FFF2-40B4-BE49-F238E27FC236}">
                <a16:creationId xmlns:a16="http://schemas.microsoft.com/office/drawing/2014/main" id="{1985846D-99A9-F472-5EF5-7771CFC56C28}"/>
              </a:ext>
            </a:extLst>
          </p:cNvPr>
          <p:cNvSpPr/>
          <p:nvPr/>
        </p:nvSpPr>
        <p:spPr>
          <a:xfrm>
            <a:off x="685800" y="984988"/>
            <a:ext cx="5486400" cy="321427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977 deemed eligible</a:t>
            </a:r>
          </a:p>
        </p:txBody>
      </p:sp>
      <p:sp>
        <p:nvSpPr>
          <p:cNvPr id="21" name="Rectangle: Rounded Corners 20">
            <a:extLst>
              <a:ext uri="{FF2B5EF4-FFF2-40B4-BE49-F238E27FC236}">
                <a16:creationId xmlns:a16="http://schemas.microsoft.com/office/drawing/2014/main" id="{5FA9A6CC-3487-981C-7DAD-B42F2409833C}"/>
              </a:ext>
            </a:extLst>
          </p:cNvPr>
          <p:cNvSpPr/>
          <p:nvPr/>
        </p:nvSpPr>
        <p:spPr>
          <a:xfrm>
            <a:off x="4468929" y="3590392"/>
            <a:ext cx="2313432" cy="64008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6 no valid T1 PD dat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AAABFA2-A5C7-650B-7693-540B6238456B}"/>
              </a:ext>
            </a:extLst>
          </p:cNvPr>
          <p:cNvSpPr txBox="1"/>
          <p:nvPr/>
        </p:nvSpPr>
        <p:spPr>
          <a:xfrm>
            <a:off x="0" y="-10675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al Material 2. CONSORT diagram of analytic sample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CE847D5E-98DD-8B13-F2A9-D6A5770CECC2}"/>
              </a:ext>
            </a:extLst>
          </p:cNvPr>
          <p:cNvSpPr/>
          <p:nvPr/>
        </p:nvSpPr>
        <p:spPr>
          <a:xfrm>
            <a:off x="2479320" y="4224547"/>
            <a:ext cx="1899360" cy="557784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556 at T1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2F85BFE0-0E20-0D9C-867C-AEDAC0928AE8}"/>
              </a:ext>
            </a:extLst>
          </p:cNvPr>
          <p:cNvSpPr/>
          <p:nvPr/>
        </p:nvSpPr>
        <p:spPr>
          <a:xfrm>
            <a:off x="2479320" y="5418473"/>
            <a:ext cx="1899360" cy="557784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334 at T2</a:t>
            </a: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C07F3EBF-8EE4-66A1-15F3-A40111E8385F}"/>
              </a:ext>
            </a:extLst>
          </p:cNvPr>
          <p:cNvSpPr/>
          <p:nvPr/>
        </p:nvSpPr>
        <p:spPr>
          <a:xfrm>
            <a:off x="2479320" y="6613190"/>
            <a:ext cx="1899360" cy="557784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221 at T3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64C59D0C-1982-3ABC-AB32-1CA76BC3259B}"/>
              </a:ext>
            </a:extLst>
          </p:cNvPr>
          <p:cNvCxnSpPr>
            <a:cxnSpLocks/>
            <a:stCxn id="18" idx="2"/>
            <a:endCxn id="8" idx="0"/>
          </p:cNvCxnSpPr>
          <p:nvPr/>
        </p:nvCxnSpPr>
        <p:spPr>
          <a:xfrm>
            <a:off x="3429000" y="2277932"/>
            <a:ext cx="0" cy="755295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5550D74B-9196-80D5-D500-A17929C16779}"/>
              </a:ext>
            </a:extLst>
          </p:cNvPr>
          <p:cNvCxnSpPr>
            <a:cxnSpLocks/>
            <a:stCxn id="8" idx="2"/>
            <a:endCxn id="4" idx="0"/>
          </p:cNvCxnSpPr>
          <p:nvPr/>
        </p:nvCxnSpPr>
        <p:spPr>
          <a:xfrm>
            <a:off x="3429000" y="3588414"/>
            <a:ext cx="0" cy="636143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393F913A-2C32-3633-24A4-92353C6CF03D}"/>
              </a:ext>
            </a:extLst>
          </p:cNvPr>
          <p:cNvCxnSpPr>
            <a:cxnSpLocks/>
            <a:stCxn id="4" idx="2"/>
            <a:endCxn id="5" idx="0"/>
          </p:cNvCxnSpPr>
          <p:nvPr/>
        </p:nvCxnSpPr>
        <p:spPr>
          <a:xfrm>
            <a:off x="3429000" y="4782340"/>
            <a:ext cx="0" cy="636143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598B53BB-00F8-959E-EF82-83461AE9FBBE}"/>
              </a:ext>
            </a:extLst>
          </p:cNvPr>
          <p:cNvCxnSpPr>
            <a:cxnSpLocks/>
            <a:stCxn id="5" idx="2"/>
            <a:endCxn id="6" idx="0"/>
          </p:cNvCxnSpPr>
          <p:nvPr/>
        </p:nvCxnSpPr>
        <p:spPr>
          <a:xfrm>
            <a:off x="3429000" y="5976259"/>
            <a:ext cx="0" cy="636932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50738FAE-658F-2286-7062-90318DCC0745}"/>
              </a:ext>
            </a:extLst>
          </p:cNvPr>
          <p:cNvCxnSpPr>
            <a:cxnSpLocks/>
            <a:stCxn id="6" idx="2"/>
            <a:endCxn id="13" idx="0"/>
          </p:cNvCxnSpPr>
          <p:nvPr/>
        </p:nvCxnSpPr>
        <p:spPr>
          <a:xfrm>
            <a:off x="3429000" y="7170976"/>
            <a:ext cx="0" cy="636932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172A062B-0F71-09B9-5DBD-D86AC13510B8}"/>
              </a:ext>
            </a:extLst>
          </p:cNvPr>
          <p:cNvSpPr txBox="1"/>
          <p:nvPr/>
        </p:nvSpPr>
        <p:spPr>
          <a:xfrm>
            <a:off x="-14934" y="8444838"/>
            <a:ext cx="3602566" cy="2614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99" dirty="0"/>
              <a:t>PD = Psychological Distress</a:t>
            </a:r>
          </a:p>
        </p:txBody>
      </p:sp>
    </p:spTree>
    <p:extLst>
      <p:ext uri="{BB962C8B-B14F-4D97-AF65-F5344CB8AC3E}">
        <p14:creationId xmlns:p14="http://schemas.microsoft.com/office/powerpoint/2010/main" val="3346016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2a472b2-3426-4696-97ea-1b8fbe7c76b6">
      <Terms xmlns="http://schemas.microsoft.com/office/infopath/2007/PartnerControls"/>
    </lcf76f155ced4ddcb4097134ff3c332f>
    <TaxCatchAll xmlns="89e2034d-8fd2-4e1a-b2a5-92d5d4497034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661E82661F526418E53B0CAD6492DFB" ma:contentTypeVersion="13" ma:contentTypeDescription="Create a new document." ma:contentTypeScope="" ma:versionID="ca1cc7a7d3dff41b095998c49c3adae1">
  <xsd:schema xmlns:xsd="http://www.w3.org/2001/XMLSchema" xmlns:xs="http://www.w3.org/2001/XMLSchema" xmlns:p="http://schemas.microsoft.com/office/2006/metadata/properties" xmlns:ns2="32a472b2-3426-4696-97ea-1b8fbe7c76b6" xmlns:ns3="89e2034d-8fd2-4e1a-b2a5-92d5d4497034" targetNamespace="http://schemas.microsoft.com/office/2006/metadata/properties" ma:root="true" ma:fieldsID="ddff77912aabbac07f2d9ec6d62b9541" ns2:_="" ns3:_="">
    <xsd:import namespace="32a472b2-3426-4696-97ea-1b8fbe7c76b6"/>
    <xsd:import namespace="89e2034d-8fd2-4e1a-b2a5-92d5d449703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MediaServiceSearchPropertie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a472b2-3426-4696-97ea-1b8fbe7c76b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c08985e1-58d1-4979-a29a-a67426b5439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9e2034d-8fd2-4e1a-b2a5-92d5d4497034" elementFormDefault="qualified">
    <xsd:import namespace="http://schemas.microsoft.com/office/2006/documentManagement/types"/>
    <xsd:import namespace="http://schemas.microsoft.com/office/infopath/2007/PartnerControls"/>
    <xsd:element name="SharedWithUsers" ma:index="1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c863999d-ba27-4d5c-8d0d-1fba72fbe27f}" ma:internalName="TaxCatchAll" ma:showField="CatchAllData" ma:web="89e2034d-8fd2-4e1a-b2a5-92d5d449703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6158B4CB-A9D7-43F8-88F0-E4A76376115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078E1B4-1813-40E6-8E44-3C97FA6B9FB6}">
  <ds:schemaRefs>
    <ds:schemaRef ds:uri="http://schemas.microsoft.com/office/2006/metadata/properties"/>
    <ds:schemaRef ds:uri="http://schemas.microsoft.com/office/infopath/2007/PartnerControls"/>
    <ds:schemaRef ds:uri="32a472b2-3426-4696-97ea-1b8fbe7c76b6"/>
    <ds:schemaRef ds:uri="89e2034d-8fd2-4e1a-b2a5-92d5d4497034"/>
  </ds:schemaRefs>
</ds:datastoreItem>
</file>

<file path=customXml/itemProps3.xml><?xml version="1.0" encoding="utf-8"?>
<ds:datastoreItem xmlns:ds="http://schemas.openxmlformats.org/officeDocument/2006/customXml" ds:itemID="{8775638A-9B56-4BB7-B946-579D5924E61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2a472b2-3426-4696-97ea-1b8fbe7c76b6"/>
    <ds:schemaRef ds:uri="89e2034d-8fd2-4e1a-b2a5-92d5d449703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6</TotalTime>
  <Words>96</Words>
  <Application>Microsoft Office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raig Heck</dc:creator>
  <cp:lastModifiedBy>Heck, Craig J.</cp:lastModifiedBy>
  <cp:revision>1</cp:revision>
  <dcterms:created xsi:type="dcterms:W3CDTF">2023-09-22T17:10:14Z</dcterms:created>
  <dcterms:modified xsi:type="dcterms:W3CDTF">2024-07-17T12:13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661E82661F526418E53B0CAD6492DFB</vt:lpwstr>
  </property>
  <property fmtid="{D5CDD505-2E9C-101B-9397-08002B2CF9AE}" pid="3" name="MediaServiceImageTags">
    <vt:lpwstr/>
  </property>
</Properties>
</file>